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0" d="100"/>
          <a:sy n="80" d="100"/>
        </p:scale>
        <p:origin x="-67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868100" cy="368681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NZ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NZ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NZ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027F4A-A67A-4687-91F4-DACC900E472A}" type="datetimeFigureOut">
              <a:rPr lang="en-NZ" smtClean="0"/>
              <a:pPr/>
              <a:t>26/02/2020</a:t>
            </a:fld>
            <a:endParaRPr lang="en-NZ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5361FC-7AFB-4081-8C27-3BAB4194D24F}" type="slidenum">
              <a:rPr lang="en-NZ" smtClean="0"/>
              <a:pPr/>
              <a:t>‹#›</a:t>
            </a:fld>
            <a:endParaRPr lang="en-NZ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0" name="Straight Arrow Connector 89"/>
          <p:cNvCxnSpPr/>
          <p:nvPr/>
        </p:nvCxnSpPr>
        <p:spPr>
          <a:xfrm>
            <a:off x="4136136" y="4437888"/>
            <a:ext cx="3048" cy="56997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6" name="Group 35"/>
          <p:cNvGrpSpPr/>
          <p:nvPr/>
        </p:nvGrpSpPr>
        <p:grpSpPr>
          <a:xfrm>
            <a:off x="3831336" y="667512"/>
            <a:ext cx="2706629" cy="307777"/>
            <a:chOff x="3849624" y="923544"/>
            <a:chExt cx="2706629" cy="307777"/>
          </a:xfrm>
        </p:grpSpPr>
        <p:sp>
          <p:nvSpPr>
            <p:cNvPr id="4" name="TextBox 3"/>
            <p:cNvSpPr txBox="1"/>
            <p:nvPr/>
          </p:nvSpPr>
          <p:spPr>
            <a:xfrm>
              <a:off x="3849624" y="923544"/>
              <a:ext cx="93166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CB0129</a:t>
              </a:r>
              <a:r>
                <a:rPr lang="en-GB" sz="1400" baseline="30000" smtClean="0">
                  <a:latin typeface="Arial" pitchFamily="34" charset="0"/>
                  <a:cs typeface="Arial" pitchFamily="34" charset="0"/>
                </a:rPr>
                <a:t>1</a:t>
              </a:r>
              <a:endParaRPr lang="en-NZ" sz="1400" baseline="30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645152" y="954322"/>
              <a:ext cx="19111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thi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, 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eu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, 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thyA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, 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deoB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,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 supE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3886200" y="1609344"/>
            <a:ext cx="3048835" cy="307777"/>
            <a:chOff x="3886200" y="1609344"/>
            <a:chExt cx="3048835" cy="307777"/>
          </a:xfrm>
        </p:grpSpPr>
        <p:sp>
          <p:nvSpPr>
            <p:cNvPr id="6" name="TextBox 5"/>
            <p:cNvSpPr txBox="1"/>
            <p:nvPr/>
          </p:nvSpPr>
          <p:spPr>
            <a:xfrm>
              <a:off x="3886200" y="1609344"/>
              <a:ext cx="9071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LT812</a:t>
              </a:r>
              <a:r>
                <a:rPr lang="en-GB" sz="1400" baseline="30000" smtClean="0">
                  <a:latin typeface="Arial" pitchFamily="34" charset="0"/>
                  <a:cs typeface="Arial" pitchFamily="34" charset="0"/>
                </a:rPr>
                <a:t>2</a:t>
              </a:r>
              <a:endParaRPr lang="en-NZ" sz="1400" baseline="30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636008" y="1640122"/>
              <a:ext cx="22990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ara-leu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)7696, 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zac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3051::Tn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10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5" name="Group 34"/>
          <p:cNvGrpSpPr/>
          <p:nvPr/>
        </p:nvGrpSpPr>
        <p:grpSpPr>
          <a:xfrm>
            <a:off x="5705856" y="2473452"/>
            <a:ext cx="1588094" cy="307777"/>
            <a:chOff x="5678424" y="2688336"/>
            <a:chExt cx="1588094" cy="307777"/>
          </a:xfrm>
        </p:grpSpPr>
        <p:sp>
          <p:nvSpPr>
            <p:cNvPr id="7" name="TextBox 6"/>
            <p:cNvSpPr txBox="1"/>
            <p:nvPr/>
          </p:nvSpPr>
          <p:spPr>
            <a:xfrm>
              <a:off x="5678424" y="2688336"/>
              <a:ext cx="10064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LT1215</a:t>
              </a:r>
              <a:r>
                <a:rPr lang="en-GB" sz="1400" baseline="30000" smtClean="0">
                  <a:latin typeface="Arial" pitchFamily="34" charset="0"/>
                  <a:cs typeface="Arial" pitchFamily="34" charset="0"/>
                </a:rPr>
                <a:t>3</a:t>
              </a:r>
              <a:endParaRPr lang="en-NZ" sz="1400" baseline="30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528816" y="2719114"/>
              <a:ext cx="7377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rpsL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812</a:t>
              </a:r>
              <a:endParaRPr lang="en-NZ" sz="12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5687568" y="3300984"/>
            <a:ext cx="1787521" cy="307777"/>
            <a:chOff x="5696712" y="3264408"/>
            <a:chExt cx="1787521" cy="307777"/>
          </a:xfrm>
        </p:grpSpPr>
        <p:sp>
          <p:nvSpPr>
            <p:cNvPr id="8" name="TextBox 7"/>
            <p:cNvSpPr txBox="1"/>
            <p:nvPr/>
          </p:nvSpPr>
          <p:spPr>
            <a:xfrm>
              <a:off x="5696712" y="3264408"/>
              <a:ext cx="100649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LT2074</a:t>
              </a:r>
              <a:r>
                <a:rPr lang="en-GB" sz="1400" baseline="30000" smtClean="0">
                  <a:latin typeface="Arial" pitchFamily="34" charset="0"/>
                  <a:cs typeface="Arial" pitchFamily="34" charset="0"/>
                </a:rPr>
                <a:t>4</a:t>
              </a:r>
              <a:endParaRPr lang="en-NZ" sz="1400" baseline="30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565392" y="3295186"/>
              <a:ext cx="9188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xylE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::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sopC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0" name="Group 39"/>
          <p:cNvGrpSpPr/>
          <p:nvPr/>
        </p:nvGrpSpPr>
        <p:grpSpPr>
          <a:xfrm>
            <a:off x="1188720" y="2473452"/>
            <a:ext cx="2280592" cy="307777"/>
            <a:chOff x="1207008" y="2468880"/>
            <a:chExt cx="2280592" cy="307777"/>
          </a:xfrm>
        </p:grpSpPr>
        <p:sp>
          <p:nvSpPr>
            <p:cNvPr id="9" name="TextBox 8"/>
            <p:cNvSpPr txBox="1"/>
            <p:nvPr/>
          </p:nvSpPr>
          <p:spPr>
            <a:xfrm>
              <a:off x="1207008" y="2468880"/>
              <a:ext cx="90710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LT1912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57400" y="2499658"/>
              <a:ext cx="14302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W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Pcp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18::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araE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533</a:t>
              </a:r>
              <a:endParaRPr lang="en-NZ" sz="120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9" name="Group 38"/>
          <p:cNvGrpSpPr/>
          <p:nvPr/>
        </p:nvGrpSpPr>
        <p:grpSpPr>
          <a:xfrm>
            <a:off x="1188720" y="3300984"/>
            <a:ext cx="1381393" cy="307777"/>
            <a:chOff x="1133856" y="3163824"/>
            <a:chExt cx="1381393" cy="307777"/>
          </a:xfrm>
        </p:grpSpPr>
        <p:sp>
          <p:nvSpPr>
            <p:cNvPr id="10" name="TextBox 9"/>
            <p:cNvSpPr txBox="1"/>
            <p:nvPr/>
          </p:nvSpPr>
          <p:spPr>
            <a:xfrm>
              <a:off x="1133856" y="3163824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35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73352" y="3194602"/>
              <a:ext cx="8418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araFGH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1170432" y="4128516"/>
            <a:ext cx="1619293" cy="307777"/>
            <a:chOff x="1179576" y="4434840"/>
            <a:chExt cx="1619293" cy="307777"/>
          </a:xfrm>
        </p:grpSpPr>
        <p:sp>
          <p:nvSpPr>
            <p:cNvPr id="11" name="TextBox 10"/>
            <p:cNvSpPr txBox="1"/>
            <p:nvPr/>
          </p:nvSpPr>
          <p:spPr>
            <a:xfrm>
              <a:off x="1179576" y="443484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50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737360" y="4465618"/>
              <a:ext cx="10615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l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RS45-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sopC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7" name="Group 46"/>
          <p:cNvGrpSpPr/>
          <p:nvPr/>
        </p:nvGrpSpPr>
        <p:grpSpPr>
          <a:xfrm>
            <a:off x="5568696" y="4128516"/>
            <a:ext cx="2295760" cy="307777"/>
            <a:chOff x="5568696" y="4133088"/>
            <a:chExt cx="2295760" cy="307777"/>
          </a:xfrm>
        </p:grpSpPr>
        <p:sp>
          <p:nvSpPr>
            <p:cNvPr id="12" name="TextBox 11"/>
            <p:cNvSpPr txBox="1"/>
            <p:nvPr/>
          </p:nvSpPr>
          <p:spPr>
            <a:xfrm>
              <a:off x="5568696" y="4133088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43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126480" y="4163866"/>
              <a:ext cx="173797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l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RS88-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4xIR-pcry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::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Z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063240" y="4128516"/>
            <a:ext cx="1969222" cy="307777"/>
            <a:chOff x="3081528" y="4379976"/>
            <a:chExt cx="1969222" cy="307777"/>
          </a:xfrm>
        </p:grpSpPr>
        <p:sp>
          <p:nvSpPr>
            <p:cNvPr id="14" name="TextBox 13"/>
            <p:cNvSpPr txBox="1"/>
            <p:nvPr/>
          </p:nvSpPr>
          <p:spPr>
            <a:xfrm>
              <a:off x="3081528" y="4379976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79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630168" y="4410754"/>
              <a:ext cx="14205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Z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4787, </a:t>
              </a:r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A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8" name="Group 47"/>
          <p:cNvGrpSpPr/>
          <p:nvPr/>
        </p:nvGrpSpPr>
        <p:grpSpPr>
          <a:xfrm>
            <a:off x="3044952" y="4990951"/>
            <a:ext cx="2291244" cy="307777"/>
            <a:chOff x="3474720" y="4943558"/>
            <a:chExt cx="2291244" cy="307777"/>
          </a:xfrm>
        </p:grpSpPr>
        <p:sp>
          <p:nvSpPr>
            <p:cNvPr id="15" name="TextBox 14"/>
            <p:cNvSpPr txBox="1"/>
            <p:nvPr/>
          </p:nvSpPr>
          <p:spPr>
            <a:xfrm>
              <a:off x="3474720" y="4943558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95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995928" y="4974336"/>
              <a:ext cx="17700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l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RS88-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sopC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-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pldc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::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Z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5650992" y="4990951"/>
            <a:ext cx="1938742" cy="307777"/>
            <a:chOff x="6281928" y="4937760"/>
            <a:chExt cx="1938742" cy="307777"/>
          </a:xfrm>
        </p:grpSpPr>
        <p:sp>
          <p:nvSpPr>
            <p:cNvPr id="13" name="TextBox 12"/>
            <p:cNvSpPr txBox="1"/>
            <p:nvPr/>
          </p:nvSpPr>
          <p:spPr>
            <a:xfrm>
              <a:off x="6281928" y="4937760"/>
              <a:ext cx="61266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smtClean="0">
                  <a:latin typeface="Arial" pitchFamily="34" charset="0"/>
                  <a:cs typeface="Arial" pitchFamily="34" charset="0"/>
                </a:rPr>
                <a:t>D183</a:t>
              </a:r>
              <a:endParaRPr lang="en-NZ" sz="14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800088" y="4968538"/>
              <a:ext cx="142058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Z</a:t>
              </a:r>
              <a:r>
                <a:rPr lang="en-GB" sz="1200" smtClean="0">
                  <a:latin typeface="Arial" pitchFamily="34" charset="0"/>
                  <a:cs typeface="Arial" pitchFamily="34" charset="0"/>
                </a:rPr>
                <a:t>4787, </a:t>
              </a:r>
              <a:r>
                <a:rPr lang="en-GB" sz="1200" smtClean="0">
                  <a:latin typeface="Symbol" pitchFamily="18" charset="2"/>
                  <a:cs typeface="Arial" pitchFamily="34" charset="0"/>
                </a:rPr>
                <a:t>D</a:t>
              </a:r>
              <a:r>
                <a:rPr lang="en-GB" sz="1200" i="1" smtClean="0">
                  <a:latin typeface="Arial" pitchFamily="34" charset="0"/>
                  <a:cs typeface="Arial" pitchFamily="34" charset="0"/>
                </a:rPr>
                <a:t>lacA</a:t>
              </a:r>
              <a:endParaRPr lang="en-NZ" sz="1200" i="1">
                <a:latin typeface="Arial" pitchFamily="34" charset="0"/>
                <a:cs typeface="Arial" pitchFamily="34" charset="0"/>
              </a:endParaRPr>
            </a:p>
          </p:txBody>
        </p:sp>
      </p:grpSp>
      <p:cxnSp>
        <p:nvCxnSpPr>
          <p:cNvPr id="43" name="Straight Arrow Connector 42"/>
          <p:cNvCxnSpPr>
            <a:endCxn id="6" idx="0"/>
          </p:cNvCxnSpPr>
          <p:nvPr/>
        </p:nvCxnSpPr>
        <p:spPr>
          <a:xfrm>
            <a:off x="4297681" y="1060704"/>
            <a:ext cx="42073" cy="54864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/>
          <p:cNvCxnSpPr/>
          <p:nvPr/>
        </p:nvCxnSpPr>
        <p:spPr>
          <a:xfrm flipH="1">
            <a:off x="2560320" y="1947672"/>
            <a:ext cx="1280160" cy="42062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/>
          <p:cNvCxnSpPr/>
          <p:nvPr/>
        </p:nvCxnSpPr>
        <p:spPr>
          <a:xfrm>
            <a:off x="4632960" y="1946148"/>
            <a:ext cx="1091184" cy="423672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/>
          <p:nvPr/>
        </p:nvCxnSpPr>
        <p:spPr>
          <a:xfrm>
            <a:off x="1908048" y="2813304"/>
            <a:ext cx="3048" cy="46024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/>
          <p:cNvCxnSpPr/>
          <p:nvPr/>
        </p:nvCxnSpPr>
        <p:spPr>
          <a:xfrm flipH="1">
            <a:off x="6326126" y="2788920"/>
            <a:ext cx="1522" cy="50901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 flipH="1">
            <a:off x="1891285" y="3547872"/>
            <a:ext cx="1523" cy="563880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2795016" y="2895600"/>
            <a:ext cx="789432" cy="1045464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3489960" y="2913888"/>
            <a:ext cx="2014728" cy="1054608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/>
          <p:cNvCxnSpPr/>
          <p:nvPr/>
        </p:nvCxnSpPr>
        <p:spPr>
          <a:xfrm>
            <a:off x="6333744" y="4422648"/>
            <a:ext cx="3048" cy="569976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3767328" y="1179576"/>
            <a:ext cx="1069524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P1 transduc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767584" y="2034874"/>
            <a:ext cx="1069524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P1 transduc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331976" y="2877312"/>
            <a:ext cx="1069524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P1 transduc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405128" y="3663696"/>
            <a:ext cx="992579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lysogeniza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044696" y="3331762"/>
            <a:ext cx="992579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lysogeniza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2609088" y="3331762"/>
            <a:ext cx="1069524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P1 transduc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5711952" y="2859024"/>
            <a:ext cx="1276311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integration/excis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621024" y="4553712"/>
            <a:ext cx="992579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lysogeniza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5788152" y="4553712"/>
            <a:ext cx="1069524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sz="100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P1 transduction</a:t>
            </a:r>
            <a:endParaRPr lang="en-NZ" sz="100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838200" y="5814408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Fig. </a:t>
            </a:r>
            <a:r>
              <a:rPr lang="en-GB" b="1" dirty="0" smtClean="0">
                <a:latin typeface="Arial" pitchFamily="34" charset="0"/>
                <a:cs typeface="Arial" pitchFamily="34" charset="0"/>
              </a:rPr>
              <a:t>S1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63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ave</dc:creator>
  <cp:lastModifiedBy>Dave</cp:lastModifiedBy>
  <cp:revision>6</cp:revision>
  <dcterms:created xsi:type="dcterms:W3CDTF">2019-09-27T15:38:14Z</dcterms:created>
  <dcterms:modified xsi:type="dcterms:W3CDTF">2020-02-26T09:56:43Z</dcterms:modified>
</cp:coreProperties>
</file>